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>
      <p:cViewPr varScale="1">
        <p:scale>
          <a:sx n="128" d="100"/>
          <a:sy n="128" d="100"/>
        </p:scale>
        <p:origin x="48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79CB24-38C3-79AE-2143-B5A4997B13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B99DB5B-DF42-1541-44CF-3F61E39A5E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856A1-1796-545A-7D31-88EC9FDD6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855CEF-B2A3-5F27-B027-00200D0AD9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460859-C5BE-06D1-8758-1F187520ED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4977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AECF11-A83B-D09D-C275-915B44E719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8C86E07-10B5-7AA2-3B2B-FE4F57D89EE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E911B5-00C0-1446-85C3-0EC0ADDD9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2C1CFA-FE5E-33F7-232F-185617563F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1467E6-5E77-3BEF-7C8F-5761EA7822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7899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A8ADA38-CA22-F565-59CB-E903BC44DED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D79850-A514-A337-16F1-DC9F6A8DB3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D3337C-DCF0-E098-31AF-8D6604B12D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776D9F1-299F-EFDB-ACBF-F15A6B9F9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23955DA-12FD-3D3F-F878-34D2B30402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0065DE-7CB2-0F44-DE31-AFB83B512C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9A2F680-8700-2237-B3EB-7DE5D3341CD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A94465-5D26-4516-F59F-84B0C05446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BFD60C-4059-427F-8FDA-CCF3670309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0CCE32A-744A-A6C1-330F-02120334B0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1597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91285E-B7E4-CAE3-DEBA-06C31FF1EB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4A9AFA-BAA5-AE9F-ED25-45CAF2E076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C30221E-6FB9-05E4-424D-129DD29277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5EE191-65D9-C83C-AD19-02759C4E43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D03BF-04F6-07D1-26C6-685F81E080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6634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15C5B8-748D-0E5C-D206-BE20CE2E22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C6A3992-F537-D149-9443-21E6E1A9ED7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5CB345D-F217-0F19-A5B1-63519F9737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852FF1-476C-69D6-9E22-8DB38FD0DD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9C6B846-A922-D283-4E36-1AFBB28C31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900C72-5B36-1104-D905-43487AD7A5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9231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ED4E0A-9352-A89F-EB56-D5F03C30DB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12BEBE4-0CDB-EC76-8B01-2C745E367FD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3C7DDD-0E06-6F00-6DF4-4308479A263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8C4E999-A01E-CCB9-F332-4271BB9850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EB7CE03-4E44-050C-8AE6-9D545B4FDD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5776E9F-4A03-FD05-18DE-5F5E08DC23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F7AD89-9A47-DC38-88E3-6C1FA8FA13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4031AC4-0A9B-EADD-688F-5887D56AB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6665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9FE0B1-B762-2DDD-ADF3-EB45536A40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48DCD74-5AB9-2F73-3BC5-C9FED58DE1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C970FC-920F-8195-A2D7-AAEFA5D5A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AE5CCDC-E77E-AE92-C425-D85A09A535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41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5BBA306-BF16-0F48-630C-5C3D8389C3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B8326BF-C759-403C-8E09-3FC656E72A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98EEC72-1126-30F8-6FDF-FC25FD9DC3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0440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EEF9AA-0C99-3BF3-2885-CF9A2C5D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18E782-BB65-C57D-5DAB-93DE74CD9EC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348E3B3-E707-02F8-847C-B2252F0202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0C773-332F-2D40-9FEE-8C830D50C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2DCD5C9-4D3A-B576-46C8-22B56A0A84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37D200D-D482-E961-272D-E9E4EA952AC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59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F4072-2451-CF96-96D4-7D391EA5E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549CD9-4D06-2E2B-8655-3E5F011FCC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A5EC0B-FB46-6313-A40A-D699EF6BCE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9ED5D0-39B1-547C-055D-C5DB413A70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AEA4C80-C9E1-1F9D-34DD-C3E592EE49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49F1D8-CCBF-F0A0-464B-CF8CE7A011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235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1E1F0BC-1C6E-E892-7635-F793AE5E80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DA04E3-3D7A-A023-5277-A781CF819DE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73CDA6-D7E6-B2F4-1F66-B839DA480D0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890573-9C61-9B42-A71A-7BC09BCE7B66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6701F3-7979-8DAC-C6C7-626D985765A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5A4BAF-559A-6EF5-0C0F-D273B763E71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905A49-7376-1045-97EE-53CDFE45F22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44911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C9A555BA-99CB-4A2B-A106-3DD9189351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936" y="325929"/>
            <a:ext cx="3978093" cy="2284715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ED7BC21-D014-4EA8-4710-0E10930E45C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37079" y="329739"/>
            <a:ext cx="3969133" cy="2284715"/>
          </a:xfrm>
          <a:prstGeom prst="rect">
            <a:avLst/>
          </a:prstGeom>
        </p:spPr>
      </p:pic>
      <p:pic>
        <p:nvPicPr>
          <p:cNvPr id="9" name="Picture 8" descr="A picture containing dark, jellyfish&#10;&#10;Description automatically generated">
            <a:extLst>
              <a:ext uri="{FF2B5EF4-FFF2-40B4-BE49-F238E27FC236}">
                <a16:creationId xmlns:a16="http://schemas.microsoft.com/office/drawing/2014/main" id="{BD364FC6-B1E2-2FAA-72BB-D82D1BE3486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88522" y="325929"/>
            <a:ext cx="3933293" cy="2428069"/>
          </a:xfrm>
          <a:prstGeom prst="rect">
            <a:avLst/>
          </a:prstGeom>
        </p:spPr>
      </p:pic>
      <p:pic>
        <p:nvPicPr>
          <p:cNvPr id="11" name="Picture 10" descr="A picture containing dark, jellyfish&#10;&#10;Description automatically generated">
            <a:extLst>
              <a:ext uri="{FF2B5EF4-FFF2-40B4-BE49-F238E27FC236}">
                <a16:creationId xmlns:a16="http://schemas.microsoft.com/office/drawing/2014/main" id="{3AF2F8E0-D92F-8465-6E3F-53171800D0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8442" y="2738714"/>
            <a:ext cx="3969133" cy="2239917"/>
          </a:xfrm>
          <a:prstGeom prst="rect">
            <a:avLst/>
          </a:prstGeom>
        </p:spPr>
      </p:pic>
      <p:pic>
        <p:nvPicPr>
          <p:cNvPr id="14" name="Picture 13" descr="A picture containing invertebrate, jellyfish, coelenterate&#10;&#10;Description automatically generated">
            <a:extLst>
              <a:ext uri="{FF2B5EF4-FFF2-40B4-BE49-F238E27FC236}">
                <a16:creationId xmlns:a16="http://schemas.microsoft.com/office/drawing/2014/main" id="{7065A76C-F8A9-8D6E-AFBC-0EEAB0C8F22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062971" y="2702876"/>
            <a:ext cx="3960173" cy="2275755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843CCBF-438B-1C4D-73A2-6B63FAC5771E}"/>
              </a:ext>
            </a:extLst>
          </p:cNvPr>
          <p:cNvSpPr txBox="1"/>
          <p:nvPr/>
        </p:nvSpPr>
        <p:spPr>
          <a:xfrm>
            <a:off x="2255108" y="225201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73_Brain 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D844304-D79B-FADF-D7DA-F5E5ABCEB394}"/>
              </a:ext>
            </a:extLst>
          </p:cNvPr>
          <p:cNvSpPr txBox="1"/>
          <p:nvPr/>
        </p:nvSpPr>
        <p:spPr>
          <a:xfrm>
            <a:off x="6204855" y="2241312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73_Brain 2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FA59C2-29C0-C5D9-D873-B100800B5C64}"/>
              </a:ext>
            </a:extLst>
          </p:cNvPr>
          <p:cNvSpPr txBox="1"/>
          <p:nvPr/>
        </p:nvSpPr>
        <p:spPr>
          <a:xfrm>
            <a:off x="10269348" y="2245385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73_Brain 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F3A484DB-8DBE-CB90-DBF1-8E2680089A5A}"/>
              </a:ext>
            </a:extLst>
          </p:cNvPr>
          <p:cNvSpPr txBox="1"/>
          <p:nvPr/>
        </p:nvSpPr>
        <p:spPr>
          <a:xfrm>
            <a:off x="2245126" y="4621398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73_Brain 4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14651CAE-0FC1-242C-7158-269C4EF0917C}"/>
              </a:ext>
            </a:extLst>
          </p:cNvPr>
          <p:cNvSpPr txBox="1"/>
          <p:nvPr/>
        </p:nvSpPr>
        <p:spPr>
          <a:xfrm>
            <a:off x="6220016" y="4609299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1973_Brain 5</a:t>
            </a:r>
          </a:p>
        </p:txBody>
      </p:sp>
      <p:pic>
        <p:nvPicPr>
          <p:cNvPr id="18" name="Picture 17" descr="A picture containing text, dark, jellyfish&#10;&#10;Description automatically generated">
            <a:extLst>
              <a:ext uri="{FF2B5EF4-FFF2-40B4-BE49-F238E27FC236}">
                <a16:creationId xmlns:a16="http://schemas.microsoft.com/office/drawing/2014/main" id="{C8C40874-6A44-EDE4-0519-30657895CAF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5936" y="5414487"/>
            <a:ext cx="3951657" cy="2375770"/>
          </a:xfrm>
          <a:prstGeom prst="rect">
            <a:avLst/>
          </a:prstGeom>
        </p:spPr>
      </p:pic>
      <p:pic>
        <p:nvPicPr>
          <p:cNvPr id="25" name="Picture 24" descr="A picture containing jellyfish, dark&#10;&#10;Description automatically generated">
            <a:extLst>
              <a:ext uri="{FF2B5EF4-FFF2-40B4-BE49-F238E27FC236}">
                <a16:creationId xmlns:a16="http://schemas.microsoft.com/office/drawing/2014/main" id="{3439BB6D-8C6E-7964-A641-D6C5CF10C96A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4059775" y="5419280"/>
            <a:ext cx="3897547" cy="2375770"/>
          </a:xfrm>
          <a:prstGeom prst="rect">
            <a:avLst/>
          </a:prstGeom>
        </p:spPr>
      </p:pic>
      <p:pic>
        <p:nvPicPr>
          <p:cNvPr id="27" name="Picture 26" descr="A picture containing colorful, jellyfish&#10;&#10;Description automatically generated">
            <a:extLst>
              <a:ext uri="{FF2B5EF4-FFF2-40B4-BE49-F238E27FC236}">
                <a16:creationId xmlns:a16="http://schemas.microsoft.com/office/drawing/2014/main" id="{E585A493-0698-A0AA-EAE9-256043E9415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8019504" y="5414487"/>
            <a:ext cx="3865442" cy="2253771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1D554877-0BEE-1902-BFEC-1997F29865BF}"/>
              </a:ext>
            </a:extLst>
          </p:cNvPr>
          <p:cNvSpPr txBox="1"/>
          <p:nvPr/>
        </p:nvSpPr>
        <p:spPr>
          <a:xfrm>
            <a:off x="2021764" y="729892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0860_Brain 1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6C23B45-3B4A-A34F-C3DA-EFD86BFCA318}"/>
              </a:ext>
            </a:extLst>
          </p:cNvPr>
          <p:cNvSpPr txBox="1"/>
          <p:nvPr/>
        </p:nvSpPr>
        <p:spPr>
          <a:xfrm>
            <a:off x="6043675" y="7298926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0860_Brain 2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C5C9B0FF-F9B3-6BFF-C7BD-7E230A6BAAEE}"/>
              </a:ext>
            </a:extLst>
          </p:cNvPr>
          <p:cNvSpPr txBox="1"/>
          <p:nvPr/>
        </p:nvSpPr>
        <p:spPr>
          <a:xfrm>
            <a:off x="9952225" y="7277594"/>
            <a:ext cx="17524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chemeClr val="bg1"/>
                </a:solidFill>
              </a:rPr>
              <a:t>SS00860_Brain 3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B4CE05E-CE0B-AB9C-BB06-790696FEF7EB}"/>
              </a:ext>
            </a:extLst>
          </p:cNvPr>
          <p:cNvSpPr txBox="1"/>
          <p:nvPr/>
        </p:nvSpPr>
        <p:spPr>
          <a:xfrm>
            <a:off x="76551" y="0"/>
            <a:ext cx="5642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MBON-j1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1A97BC7-D4FF-860A-7B4A-2ACF448BCC16}"/>
              </a:ext>
            </a:extLst>
          </p:cNvPr>
          <p:cNvSpPr txBox="1"/>
          <p:nvPr/>
        </p:nvSpPr>
        <p:spPr>
          <a:xfrm>
            <a:off x="76550" y="4978631"/>
            <a:ext cx="5642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Adult immortalized anatomy of larval neuron MBON-j2</a:t>
            </a:r>
          </a:p>
        </p:txBody>
      </p:sp>
    </p:spTree>
    <p:extLst>
      <p:ext uri="{BB962C8B-B14F-4D97-AF65-F5344CB8AC3E}">
        <p14:creationId xmlns:p14="http://schemas.microsoft.com/office/powerpoint/2010/main" val="727238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46</Words>
  <Application>Microsoft Macintosh PowerPoint</Application>
  <PresentationFormat>Widescreen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uman, Jim</dc:creator>
  <cp:lastModifiedBy>Truman, Jim</cp:lastModifiedBy>
  <cp:revision>15</cp:revision>
  <dcterms:created xsi:type="dcterms:W3CDTF">2022-06-08T22:16:26Z</dcterms:created>
  <dcterms:modified xsi:type="dcterms:W3CDTF">2022-06-08T22:55:08Z</dcterms:modified>
</cp:coreProperties>
</file>